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8" r:id="rId3"/>
    <p:sldId id="264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4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6DD075-0085-58AE-4BC0-571336F895B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00A18C6-6BE1-1CF9-D79E-DA5B739AB52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3FF228-327A-6D88-2EAF-DCB1449256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33A93-6FBD-4A51-AEF9-69517A878B60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A1AF47-A1E6-F927-50A2-1CA1F2DEB1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3667A3-11BF-BC13-589C-C70A7E30BE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87F34-2924-4F10-ABF7-4B7713A68C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156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7B0A23-B32B-E4E6-F260-22EC8FF9CC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1916E6C-E112-6630-8314-926CBA1DB3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CD0A96-0F52-D14C-C9C1-4F56A08D90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33A93-6FBD-4A51-AEF9-69517A878B60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400AF8-ADCA-2DD9-19A1-47FA8697C5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EB6ECA-6FD8-2C3D-3549-E9527EF004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87F34-2924-4F10-ABF7-4B7713A68C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021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307BE3F-BAD9-757C-16B5-B3AD1A566BA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D8E3813-1383-AACF-5803-6DDEA76BEA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8D2868-284D-E9E5-6973-37A0DF185B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33A93-6FBD-4A51-AEF9-69517A878B60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107B3F-650B-6377-0935-19364D3C8B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95EA0B-916F-F98C-4717-0767C4D728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87F34-2924-4F10-ABF7-4B7713A68C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7317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7C1338-66BC-0B1E-C646-EF4CF04817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7D2EFF-84E6-EACF-1C84-FA324976E73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AE9ABB-623C-5681-70D3-90C8FE7BC5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33A93-6FBD-4A51-AEF9-69517A878B60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585779-2E9C-AC42-1E57-3C0BB55EEA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24C73F-D76E-375D-AEB8-9F2B23C1B7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87F34-2924-4F10-ABF7-4B7713A68C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0363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9AB11A-6E2A-5AEE-D7DC-885FDDC00D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03DF19C-C16C-F4E6-0E0C-C95352DFB4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B9D354-9FE2-36DA-FDAF-7D5E976329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33A93-6FBD-4A51-AEF9-69517A878B60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9C3157-6E04-E0D1-4577-F92B66E969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89D00C-A289-3CCF-61D7-0DEB9603F4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87F34-2924-4F10-ABF7-4B7713A68C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8229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8A9B1B-CC9E-BB10-43B9-C71CAFAF3A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08A653-E4AE-B38B-A83D-7D4247B8650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4134F1-B480-7915-1D7F-188C4E89CB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FC1B56-1C55-C483-9128-F98D59876F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33A93-6FBD-4A51-AEF9-69517A878B60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8FA7CF5-9385-6AD7-C3A8-AC5F7B325F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52ED80-2206-4EFE-A8D5-02934A150B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87F34-2924-4F10-ABF7-4B7713A68C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4707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07BB37-12D2-98D5-5E1A-4F840FFCE8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D3A261-48F9-6AAC-7876-D6FD2924BC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FBFCF20-149B-6266-87B0-99B63FA308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0D0B287-0C6D-EC06-9FF8-344E907AD16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0D54F30-80B1-606B-2C7A-6BF0CDB1A90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4B25659-B504-C084-C2DE-3D00680E07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33A93-6FBD-4A51-AEF9-69517A878B60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5A58C8B-4627-42F3-7C38-A4C5168B4D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A3C657D-568B-5391-D052-4090C5F57D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87F34-2924-4F10-ABF7-4B7713A68C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2696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E9B9AD-F9E8-37E1-0A91-1E25A91C6C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D6491EB-94EF-10FC-CEE3-8CCE04CBAB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33A93-6FBD-4A51-AEF9-69517A878B60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555BC1A-BEB9-711F-FB56-76CA0DB407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6272CFE-94B3-C393-BE2C-67B0D0C849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87F34-2924-4F10-ABF7-4B7713A68C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6375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BBFA9D6-D749-C4FB-000D-2E2B3CE9A8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33A93-6FBD-4A51-AEF9-69517A878B60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4C25EBD-4005-7388-1C2B-2D98DFB028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C5DD138-7CDF-7754-561B-50BE7AE155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87F34-2924-4F10-ABF7-4B7713A68C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77041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EC1048-B5A9-95B2-B6CE-7EAE1E6AC7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7B6DFB-C419-5BBB-BC21-9EB25DB340E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F3B9467-23FA-3CDC-0BC8-5BF166250F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0DC9D2-9A82-A930-C8DA-69AD44291D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33A93-6FBD-4A51-AEF9-69517A878B60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8C65E4-8084-DCA5-99CB-0845194DAD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1DC0C07-7F83-8943-AA1B-1676B28D37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87F34-2924-4F10-ABF7-4B7713A68C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62710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0DDE09-C444-9C5B-8720-50D73A5354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039345B-1044-4B5A-5DC5-EFDA256E6C6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A08FA9-2537-F347-784E-4A0440AC94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4E7BD4-FCF8-C5EA-0598-2D9819BCB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33A93-6FBD-4A51-AEF9-69517A878B60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E67AAD-5DFE-3F5B-7484-AC54718BD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989DA3-4EEB-0D1A-D1BA-1035D8711A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87F34-2924-4F10-ABF7-4B7713A68C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40688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6DA6F97-14A0-E70B-98C2-2E8D6BE165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8191EE-DB22-DCDF-0D63-DA22829840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4FF63E-A33A-8105-E435-6A516B9F2F8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233A93-6FBD-4A51-AEF9-69517A878B60}" type="datetimeFigureOut">
              <a:rPr lang="en-US" smtClean="0"/>
              <a:t>8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97350F-78FA-1BFA-48DE-D3A4B8371A6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07F02B-4CEB-7AAD-40C8-1BF6289CD20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587F34-2924-4F10-ABF7-4B7713A68C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61858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package" Target="../embeddings/Microsoft_Excel_Worksheet.xlsx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Group 43">
            <a:extLst>
              <a:ext uri="{FF2B5EF4-FFF2-40B4-BE49-F238E27FC236}">
                <a16:creationId xmlns:a16="http://schemas.microsoft.com/office/drawing/2014/main" id="{9D67A28E-BEED-A21D-D5F4-36C70F8065B9}"/>
              </a:ext>
            </a:extLst>
          </p:cNvPr>
          <p:cNvGrpSpPr/>
          <p:nvPr/>
        </p:nvGrpSpPr>
        <p:grpSpPr>
          <a:xfrm>
            <a:off x="3175355" y="1024350"/>
            <a:ext cx="5843056" cy="4809299"/>
            <a:chOff x="2280330" y="1591849"/>
            <a:chExt cx="5843056" cy="4809299"/>
          </a:xfrm>
        </p:grpSpPr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357406FF-C7B2-4987-FADB-D765CD121CE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9738" t="52688" r="20042"/>
            <a:stretch/>
          </p:blipFill>
          <p:spPr>
            <a:xfrm>
              <a:off x="2280330" y="3156448"/>
              <a:ext cx="4387659" cy="3244700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F3B934FF-A784-6B40-14D4-798C8ECD69E3}"/>
                </a:ext>
              </a:extLst>
            </p:cNvPr>
            <p:cNvSpPr txBox="1"/>
            <p:nvPr/>
          </p:nvSpPr>
          <p:spPr>
            <a:xfrm>
              <a:off x="6576184" y="3265217"/>
              <a:ext cx="95912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i="1" dirty="0"/>
                <a:t>C. fimbriata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92D3AEF7-81E3-83CA-DA3D-3BC4AC313399}"/>
                </a:ext>
              </a:extLst>
            </p:cNvPr>
            <p:cNvSpPr txBox="1"/>
            <p:nvPr/>
          </p:nvSpPr>
          <p:spPr>
            <a:xfrm>
              <a:off x="6578967" y="3686070"/>
              <a:ext cx="103149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i="1" dirty="0"/>
                <a:t>C. </a:t>
              </a:r>
              <a:r>
                <a:rPr lang="en-US" sz="1050" b="1" i="1" dirty="0" err="1"/>
                <a:t>albifundus</a:t>
              </a:r>
              <a:endParaRPr lang="en-US" sz="1050" b="1" i="1" dirty="0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D6F3DB43-2781-18AF-A8E3-232444BEA489}"/>
                </a:ext>
              </a:extLst>
            </p:cNvPr>
            <p:cNvSpPr txBox="1"/>
            <p:nvPr/>
          </p:nvSpPr>
          <p:spPr>
            <a:xfrm rot="60000">
              <a:off x="6576056" y="5435289"/>
              <a:ext cx="154556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i="1" dirty="0"/>
                <a:t>C. destructans </a:t>
              </a:r>
              <a:r>
                <a:rPr lang="en-US" sz="1050" b="1" dirty="0"/>
                <a:t>(1428)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74B6A8C0-7E49-EDB9-F6EB-D34E76E8CFBD}"/>
                </a:ext>
              </a:extLst>
            </p:cNvPr>
            <p:cNvSpPr txBox="1"/>
            <p:nvPr/>
          </p:nvSpPr>
          <p:spPr>
            <a:xfrm>
              <a:off x="6574312" y="5860669"/>
              <a:ext cx="154556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i="1" dirty="0"/>
                <a:t>C. destructans </a:t>
              </a:r>
              <a:r>
                <a:rPr lang="en-US" sz="1050" b="1" dirty="0"/>
                <a:t>(490)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A27714D0-D50D-3A8B-37F8-2CD438862CBD}"/>
                </a:ext>
              </a:extLst>
            </p:cNvPr>
            <p:cNvSpPr txBox="1"/>
            <p:nvPr/>
          </p:nvSpPr>
          <p:spPr>
            <a:xfrm>
              <a:off x="6577823" y="4130512"/>
              <a:ext cx="154556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i="1" dirty="0"/>
                <a:t>C. destructans </a:t>
              </a:r>
              <a:r>
                <a:rPr lang="en-US" sz="1050" b="1" dirty="0"/>
                <a:t>(979)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0191ECCA-F8F2-5892-7BE6-E5B95F690680}"/>
                </a:ext>
              </a:extLst>
            </p:cNvPr>
            <p:cNvSpPr txBox="1"/>
            <p:nvPr/>
          </p:nvSpPr>
          <p:spPr>
            <a:xfrm>
              <a:off x="6577823" y="4994881"/>
              <a:ext cx="154556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i="1" dirty="0"/>
                <a:t>C. destructans </a:t>
              </a:r>
              <a:r>
                <a:rPr lang="en-US" sz="1050" b="1" dirty="0"/>
                <a:t>(1624)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808297B5-2639-AE32-0C27-281BF5FDB217}"/>
                </a:ext>
              </a:extLst>
            </p:cNvPr>
            <p:cNvSpPr txBox="1"/>
            <p:nvPr/>
          </p:nvSpPr>
          <p:spPr>
            <a:xfrm>
              <a:off x="6576865" y="4563197"/>
              <a:ext cx="154556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i="1" dirty="0"/>
                <a:t>C. destructans </a:t>
              </a:r>
              <a:r>
                <a:rPr lang="en-US" sz="1050" b="1" dirty="0"/>
                <a:t>(1622)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8972FA2B-0B6B-2EED-0FE2-E36EC08B8169}"/>
                </a:ext>
              </a:extLst>
            </p:cNvPr>
            <p:cNvSpPr txBox="1"/>
            <p:nvPr/>
          </p:nvSpPr>
          <p:spPr>
            <a:xfrm rot="18000000">
              <a:off x="2381513" y="2503704"/>
              <a:ext cx="95912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i="1" dirty="0"/>
                <a:t>C. fimbriata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66D77CDC-4DC9-932C-18FB-B2868185DA4D}"/>
                </a:ext>
              </a:extLst>
            </p:cNvPr>
            <p:cNvSpPr txBox="1"/>
            <p:nvPr/>
          </p:nvSpPr>
          <p:spPr>
            <a:xfrm rot="18000000">
              <a:off x="2966038" y="2472367"/>
              <a:ext cx="103149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i="1" dirty="0"/>
                <a:t>C. </a:t>
              </a:r>
              <a:r>
                <a:rPr lang="en-US" sz="1050" b="1" i="1" dirty="0" err="1"/>
                <a:t>albifundus</a:t>
              </a:r>
              <a:endParaRPr lang="en-US" sz="1050" b="1" i="1" dirty="0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E722931F-FF37-70E1-4F64-CA7A820FFAA6}"/>
                </a:ext>
              </a:extLst>
            </p:cNvPr>
            <p:cNvSpPr txBox="1"/>
            <p:nvPr/>
          </p:nvSpPr>
          <p:spPr>
            <a:xfrm rot="18000000">
              <a:off x="5258250" y="2237673"/>
              <a:ext cx="154556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i="1" dirty="0"/>
                <a:t>C. destructans </a:t>
              </a:r>
              <a:r>
                <a:rPr lang="en-US" sz="1050" b="1" dirty="0"/>
                <a:t>(1428)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2EAC2DEA-2A69-CBAE-772D-936E2C3C74C3}"/>
                </a:ext>
              </a:extLst>
            </p:cNvPr>
            <p:cNvSpPr txBox="1"/>
            <p:nvPr/>
          </p:nvSpPr>
          <p:spPr>
            <a:xfrm rot="18000000">
              <a:off x="5856125" y="2240531"/>
              <a:ext cx="154556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i="1" dirty="0"/>
                <a:t>C. destructans </a:t>
              </a:r>
              <a:r>
                <a:rPr lang="en-US" sz="1050" b="1" dirty="0"/>
                <a:t>(490)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563B255-6D09-96A6-E3C6-DBB14938FE58}"/>
                </a:ext>
              </a:extLst>
            </p:cNvPr>
            <p:cNvSpPr txBox="1"/>
            <p:nvPr/>
          </p:nvSpPr>
          <p:spPr>
            <a:xfrm rot="18000000">
              <a:off x="3439885" y="2246908"/>
              <a:ext cx="154556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i="1" dirty="0"/>
                <a:t>C. destructans </a:t>
              </a:r>
              <a:r>
                <a:rPr lang="en-US" sz="1050" b="1" dirty="0"/>
                <a:t>(979)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18E42D71-6B5D-01D7-8FA9-C6E650500C94}"/>
                </a:ext>
              </a:extLst>
            </p:cNvPr>
            <p:cNvSpPr txBox="1"/>
            <p:nvPr/>
          </p:nvSpPr>
          <p:spPr>
            <a:xfrm rot="18000000">
              <a:off x="4654360" y="2240532"/>
              <a:ext cx="154556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i="1" dirty="0"/>
                <a:t>C. destructans </a:t>
              </a:r>
              <a:r>
                <a:rPr lang="en-US" sz="1050" b="1" dirty="0"/>
                <a:t>(1624)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DF16E526-4A6D-C86C-F2E7-6B44912D7AAA}"/>
                </a:ext>
              </a:extLst>
            </p:cNvPr>
            <p:cNvSpPr txBox="1"/>
            <p:nvPr/>
          </p:nvSpPr>
          <p:spPr>
            <a:xfrm rot="18000000">
              <a:off x="4051740" y="2240533"/>
              <a:ext cx="154556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i="1" dirty="0"/>
                <a:t>C. destructans </a:t>
              </a:r>
              <a:r>
                <a:rPr lang="en-US" sz="1050" b="1" dirty="0"/>
                <a:t>(1622)</a:t>
              </a:r>
            </a:p>
          </p:txBody>
        </p:sp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B9880951-0F3C-828F-18FA-8D4EB2FA3D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2386" t="25502" r="20042" b="71910"/>
            <a:stretch/>
          </p:blipFill>
          <p:spPr>
            <a:xfrm>
              <a:off x="2588588" y="2978980"/>
              <a:ext cx="4156300" cy="177468"/>
            </a:xfrm>
            <a:prstGeom prst="rect">
              <a:avLst/>
            </a:prstGeom>
          </p:spPr>
        </p:pic>
      </p:grpSp>
      <p:sp>
        <p:nvSpPr>
          <p:cNvPr id="45" name="TextBox 44">
            <a:extLst>
              <a:ext uri="{FF2B5EF4-FFF2-40B4-BE49-F238E27FC236}">
                <a16:creationId xmlns:a16="http://schemas.microsoft.com/office/drawing/2014/main" id="{F6736355-5EA9-996B-2FC3-FFB8F6B51BE8}"/>
              </a:ext>
            </a:extLst>
          </p:cNvPr>
          <p:cNvSpPr txBox="1"/>
          <p:nvPr/>
        </p:nvSpPr>
        <p:spPr>
          <a:xfrm>
            <a:off x="695058" y="6086890"/>
            <a:ext cx="8867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. 1</a:t>
            </a:r>
            <a:r>
              <a:rPr lang="en-US" sz="1200" dirty="0"/>
              <a:t>. Calculated Average Nucleotide Identity (ANI) for the </a:t>
            </a:r>
            <a:r>
              <a:rPr lang="en-US" sz="1200" i="1" dirty="0"/>
              <a:t>C. destructans </a:t>
            </a:r>
            <a:r>
              <a:rPr lang="en-US" sz="1200" dirty="0"/>
              <a:t>isolates</a:t>
            </a:r>
            <a:r>
              <a:rPr lang="en-US" sz="1200" i="1" dirty="0"/>
              <a:t>,   C. </a:t>
            </a:r>
            <a:r>
              <a:rPr lang="en-US" sz="1200" i="1" dirty="0" err="1"/>
              <a:t>albifundus</a:t>
            </a:r>
            <a:r>
              <a:rPr lang="en-US" sz="1200" dirty="0"/>
              <a:t>, and </a:t>
            </a:r>
            <a:r>
              <a:rPr lang="en-US" sz="1200" i="1" dirty="0"/>
              <a:t>C. fimbriata</a:t>
            </a:r>
          </a:p>
        </p:txBody>
      </p:sp>
    </p:spTree>
    <p:extLst>
      <p:ext uri="{BB962C8B-B14F-4D97-AF65-F5344CB8AC3E}">
        <p14:creationId xmlns:p14="http://schemas.microsoft.com/office/powerpoint/2010/main" val="12915648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6D09B684-B128-CCF1-EC8C-E62D9F874CC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442"/>
          <a:stretch/>
        </p:blipFill>
        <p:spPr>
          <a:xfrm>
            <a:off x="2636693" y="0"/>
            <a:ext cx="6918614" cy="68580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10F9706-6A71-A346-0D24-0CC1B2E79067}"/>
              </a:ext>
            </a:extLst>
          </p:cNvPr>
          <p:cNvSpPr txBox="1"/>
          <p:nvPr/>
        </p:nvSpPr>
        <p:spPr>
          <a:xfrm>
            <a:off x="167780" y="5473005"/>
            <a:ext cx="334720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. 2 </a:t>
            </a:r>
          </a:p>
          <a:p>
            <a:pPr algn="just"/>
            <a:r>
              <a:rPr lang="en-US" sz="1200" dirty="0"/>
              <a:t>Phylogenomic analysis of the predicted effectors among </a:t>
            </a:r>
            <a:r>
              <a:rPr lang="en-US" sz="1200" i="1" dirty="0"/>
              <a:t>C. destructans </a:t>
            </a:r>
            <a:r>
              <a:rPr lang="en-US" sz="1200" dirty="0"/>
              <a:t>(red), </a:t>
            </a:r>
            <a:r>
              <a:rPr lang="en-US" sz="1200" i="1" dirty="0"/>
              <a:t>C. fimbriata</a:t>
            </a:r>
            <a:r>
              <a:rPr lang="en-US" sz="1200" dirty="0"/>
              <a:t> (black), and </a:t>
            </a:r>
            <a:r>
              <a:rPr lang="en-US" sz="1200" i="1" dirty="0"/>
              <a:t>C. </a:t>
            </a:r>
            <a:r>
              <a:rPr lang="en-US" sz="1200" i="1" dirty="0" err="1"/>
              <a:t>albifundus</a:t>
            </a:r>
            <a:r>
              <a:rPr lang="en-US" sz="1200" i="1" dirty="0"/>
              <a:t> </a:t>
            </a:r>
            <a:r>
              <a:rPr lang="en-US" sz="1200" dirty="0"/>
              <a:t>(blue). Branches colored in red represents effectors unique to </a:t>
            </a:r>
            <a:r>
              <a:rPr lang="en-US" sz="1200" i="1" dirty="0"/>
              <a:t>C. destructans</a:t>
            </a:r>
            <a:r>
              <a:rPr lang="en-US" sz="1200" dirty="0"/>
              <a:t>, their protein sequences and annotations are provided in Supplemental Data 1.</a:t>
            </a:r>
          </a:p>
        </p:txBody>
      </p:sp>
    </p:spTree>
    <p:extLst>
      <p:ext uri="{BB962C8B-B14F-4D97-AF65-F5344CB8AC3E}">
        <p14:creationId xmlns:p14="http://schemas.microsoft.com/office/powerpoint/2010/main" val="12189237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3C23ED49-4020-CC82-406C-271343D7169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43480148"/>
              </p:ext>
            </p:extLst>
          </p:nvPr>
        </p:nvGraphicFramePr>
        <p:xfrm>
          <a:off x="1585912" y="823912"/>
          <a:ext cx="9020175" cy="5210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9020143" imgH="5210243" progId="Excel.Sheet.12">
                  <p:embed/>
                </p:oleObj>
              </mc:Choice>
              <mc:Fallback>
                <p:oleObj name="Worksheet" r:id="rId2" imgW="9020143" imgH="5210243" progId="Excel.Sheet.12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126A0511-7253-FC37-51D8-200BFD9D47C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585912" y="823912"/>
                        <a:ext cx="9020175" cy="5210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760C87D3-2E5F-BD75-3A61-7E001C0AA006}"/>
              </a:ext>
            </a:extLst>
          </p:cNvPr>
          <p:cNvSpPr txBox="1"/>
          <p:nvPr/>
        </p:nvSpPr>
        <p:spPr>
          <a:xfrm>
            <a:off x="293450" y="6034087"/>
            <a:ext cx="11605097" cy="7783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1200"/>
              </a:spcBef>
              <a:spcAft>
                <a:spcPts val="800"/>
              </a:spcAft>
            </a:pPr>
            <a:r>
              <a:rPr lang="en-US" sz="12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upplementary Fig </a:t>
            </a:r>
            <a:r>
              <a:rPr lang="en-US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2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Distribution of secreted </a:t>
            </a:r>
            <a:r>
              <a:rPr lang="en-US" sz="12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AZymes</a:t>
            </a:r>
            <a:r>
              <a:rPr lang="en-US" sz="12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with high numbers in the </a:t>
            </a:r>
            <a:r>
              <a:rPr lang="en-US" sz="1200" i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eratocystis </a:t>
            </a:r>
            <a:r>
              <a:rPr lang="en-US" sz="12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genomes. GH: glycoside hydrolases; AA: auxiliary activities; CE: Carbohydrate esterase’s; PL: Polysaccharide lyase; CBM: carbohydrate-binding modules.</a:t>
            </a:r>
          </a:p>
        </p:txBody>
      </p:sp>
    </p:spTree>
    <p:extLst>
      <p:ext uri="{BB962C8B-B14F-4D97-AF65-F5344CB8AC3E}">
        <p14:creationId xmlns:p14="http://schemas.microsoft.com/office/powerpoint/2010/main" val="937242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787</TotalTime>
  <Words>194</Words>
  <Application>Microsoft Office PowerPoint</Application>
  <PresentationFormat>Widescreen</PresentationFormat>
  <Paragraphs>18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Worksheet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wanda Maguvu</dc:creator>
  <cp:lastModifiedBy>Tawanda Maguvu</cp:lastModifiedBy>
  <cp:revision>25</cp:revision>
  <dcterms:created xsi:type="dcterms:W3CDTF">2023-01-19T23:56:55Z</dcterms:created>
  <dcterms:modified xsi:type="dcterms:W3CDTF">2023-08-18T16:36:51Z</dcterms:modified>
</cp:coreProperties>
</file>